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721"/>
  </p:normalViewPr>
  <p:slideViewPr>
    <p:cSldViewPr snapToGrid="0" snapToObjects="1">
      <p:cViewPr>
        <p:scale>
          <a:sx n="93" d="100"/>
          <a:sy n="93" d="100"/>
        </p:scale>
        <p:origin x="-168" y="2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06825068843314"/>
          <c:y val="6.2956041316944072E-2"/>
          <c:w val="0.84493171207581297"/>
          <c:h val="0.758839719503146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[Copy of LOH plot.xlsx]Sheet1'!$D$5</c:f>
              <c:strCache>
                <c:ptCount val="1"/>
                <c:pt idx="0">
                  <c:v>% False positive LOH tract calls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pPr>
              <a:solidFill>
                <a:schemeClr val="tx1"/>
              </a:solidFill>
            </c:spPr>
          </c:marker>
          <c:xVal>
            <c:numRef>
              <c:f>'[Copy of LOH plot.xlsx]Sheet1'!$C$6:$C$19</c:f>
              <c:numCache>
                <c:formatCode>General</c:formatCode>
                <c:ptCount val="14"/>
                <c:pt idx="0">
                  <c:v>2</c:v>
                </c:pt>
                <c:pt idx="1">
                  <c:v>3</c:v>
                </c:pt>
                <c:pt idx="2">
                  <c:v>4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10</c:v>
                </c:pt>
                <c:pt idx="9">
                  <c:v>11</c:v>
                </c:pt>
                <c:pt idx="10">
                  <c:v>12</c:v>
                </c:pt>
                <c:pt idx="11">
                  <c:v>13</c:v>
                </c:pt>
                <c:pt idx="12">
                  <c:v>14</c:v>
                </c:pt>
                <c:pt idx="13">
                  <c:v>15</c:v>
                </c:pt>
              </c:numCache>
            </c:numRef>
          </c:xVal>
          <c:yVal>
            <c:numRef>
              <c:f>'[Copy of LOH plot.xlsx]Sheet1'!$D$6:$D$19</c:f>
              <c:numCache>
                <c:formatCode>General</c:formatCode>
                <c:ptCount val="14"/>
                <c:pt idx="0">
                  <c:v>45.945945945945951</c:v>
                </c:pt>
                <c:pt idx="1">
                  <c:v>22.705314009661837</c:v>
                </c:pt>
                <c:pt idx="2">
                  <c:v>13.812154696132598</c:v>
                </c:pt>
                <c:pt idx="3">
                  <c:v>11.585365853658537</c:v>
                </c:pt>
                <c:pt idx="4">
                  <c:v>10.191082802547772</c:v>
                </c:pt>
                <c:pt idx="5">
                  <c:v>6.3380281690140841</c:v>
                </c:pt>
                <c:pt idx="6">
                  <c:v>3.8167938931297711</c:v>
                </c:pt>
                <c:pt idx="7">
                  <c:v>3.225806451612903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58407680"/>
        <c:axId val="158504448"/>
      </c:scatterChart>
      <c:valAx>
        <c:axId val="1584076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SNP cut-off</a:t>
                </a:r>
              </a:p>
            </c:rich>
          </c:tx>
          <c:layout>
            <c:manualLayout>
              <c:xMode val="edge"/>
              <c:yMode val="edge"/>
              <c:x val="0.39940559656070385"/>
              <c:y val="0.8929550884236419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158504448"/>
        <c:crosses val="autoZero"/>
        <c:crossBetween val="midCat"/>
        <c:majorUnit val="2"/>
      </c:valAx>
      <c:valAx>
        <c:axId val="1585044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defRPr>
                </a:pPr>
                <a:r>
                  <a:rPr lang="en-US" sz="1200" b="1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%</a:t>
                </a:r>
                <a:r>
                  <a:rPr lang="en-US" sz="1200" b="1" baseline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 False positive LOH tract calls</a:t>
                </a:r>
                <a:endParaRPr lang="en-US" sz="1200" b="1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158407680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807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089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448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843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888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92125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991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70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15430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7745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127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4FE6D1-31F1-B44E-837B-21A144B524FC}" type="datetimeFigureOut">
              <a:rPr lang="en-US" smtClean="0"/>
              <a:t>7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F1168E-75D9-684A-85D4-EFE363B9B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627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6796684"/>
              </p:ext>
            </p:extLst>
          </p:nvPr>
        </p:nvGraphicFramePr>
        <p:xfrm>
          <a:off x="3430995" y="993729"/>
          <a:ext cx="5199380" cy="42500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/>
          <p:cNvSpPr/>
          <p:nvPr/>
        </p:nvSpPr>
        <p:spPr>
          <a:xfrm>
            <a:off x="304801" y="5243784"/>
            <a:ext cx="1123950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Validation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of LOH tracts in diploid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_57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lines using sequence data from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_57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haploid spores.  All LOH tracts in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1_57, V3_57, V4_57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5_57 diploids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supported by two or more SNPs were compared with sequence information from the corresponding haploid spores.  Plot shows the percentage </a:t>
            </a:r>
            <a:r>
              <a:rPr lang="en-IN" sz="100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IN" sz="1000" smtClean="0">
                <a:latin typeface="Arial" panose="020B0604020202020204" pitchFamily="34" charset="0"/>
                <a:cs typeface="Arial" panose="020B0604020202020204" pitchFamily="34" charset="0"/>
              </a:rPr>
              <a:t>V_57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diploid LOH tracts that could not be verified using the haploid data as some of the SNPs supporting the LOH were called differently in haploid.  </a:t>
            </a:r>
            <a:r>
              <a:rPr lang="en-I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OH </a:t>
            </a:r>
            <a:r>
              <a:rPr lang="en-IN" sz="1000" dirty="0">
                <a:latin typeface="Arial" panose="020B0604020202020204" pitchFamily="34" charset="0"/>
                <a:cs typeface="Arial" panose="020B0604020202020204" pitchFamily="34" charset="0"/>
              </a:rPr>
              <a:t>tracts in diploids supported by 10 or more SNPs were always identical in haploid data.</a:t>
            </a:r>
          </a:p>
        </p:txBody>
      </p:sp>
    </p:spTree>
    <p:extLst>
      <p:ext uri="{BB962C8B-B14F-4D97-AF65-F5344CB8AC3E}">
        <p14:creationId xmlns:p14="http://schemas.microsoft.com/office/powerpoint/2010/main" val="10817250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9</TotalTime>
  <Words>104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hishek Dutta</dc:creator>
  <cp:lastModifiedBy>IISRTVM</cp:lastModifiedBy>
  <cp:revision>21</cp:revision>
  <dcterms:created xsi:type="dcterms:W3CDTF">2016-09-23T05:19:49Z</dcterms:created>
  <dcterms:modified xsi:type="dcterms:W3CDTF">2017-07-17T11:06:06Z</dcterms:modified>
</cp:coreProperties>
</file>